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018" autoAdjust="0"/>
    <p:restoredTop sz="94660"/>
  </p:normalViewPr>
  <p:slideViewPr>
    <p:cSldViewPr snapToGrid="0">
      <p:cViewPr varScale="1">
        <p:scale>
          <a:sx n="94" d="100"/>
          <a:sy n="94" d="100"/>
        </p:scale>
        <p:origin x="86" y="4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6983CA-7CC8-78A7-E875-064845D1011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A6F7E95-34E5-5DFD-3BDB-EC3AA09A277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46B91E-AD88-4861-BD81-349EAC6891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CFFA6-FDB5-49AF-8B2D-5A78BB6DCEB2}" type="datetimeFigureOut">
              <a:rPr lang="en-GB" smtClean="0"/>
              <a:t>28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368D25D-AB4A-DDDF-393E-E7B7CA2A31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0E03CF-8734-282C-6115-D66D49F695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B18D00-7A28-4BDF-9291-FC7511BAA2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670512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BAC05A-23F7-87D5-29C8-B947C6ACE8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E60B7C7-E4CA-1DD0-9EE7-C013EE45007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004B912-99FA-F782-0D6D-49350A872B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CFFA6-FDB5-49AF-8B2D-5A78BB6DCEB2}" type="datetimeFigureOut">
              <a:rPr lang="en-GB" smtClean="0"/>
              <a:t>28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BB5F7C1-DFEB-EE7E-8213-56942085FE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1DBE0A-DED9-496E-6D61-65FD8DEB2D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B18D00-7A28-4BDF-9291-FC7511BAA2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366897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43464D1-9391-FE49-E709-5453FAFAF3F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6AB0FDF-63EA-EB7E-80C2-A49A8B3421F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959FE5-25D5-02F9-C50C-C0B21C93DB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CFFA6-FDB5-49AF-8B2D-5A78BB6DCEB2}" type="datetimeFigureOut">
              <a:rPr lang="en-GB" smtClean="0"/>
              <a:t>28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413537-594C-CD2D-4546-0F4CBF697A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B8BAA1-AAEE-1C93-E24E-7FEDEE2123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B18D00-7A28-4BDF-9291-FC7511BAA2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380878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259296-A6A8-85CF-52D5-ECBC84C79E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C12D7A1-E003-A473-CE9A-5548914EB49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222CB0-48F5-FBBB-DDF6-F37DFDDC1B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CFFA6-FDB5-49AF-8B2D-5A78BB6DCEB2}" type="datetimeFigureOut">
              <a:rPr lang="en-GB" smtClean="0"/>
              <a:t>28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6D8444-B873-9DA9-F510-81662B77CB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DF828C2-B0FE-9AE5-A19E-F489773BB7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B18D00-7A28-4BDF-9291-FC7511BAA2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7484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30E84B-EE3F-3A19-EC91-46BA05F6FB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D2F4C03-2ECF-ECC1-A95D-FD822A0CAA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2D3E7D-018B-DBB3-E311-D35AB03028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CFFA6-FDB5-49AF-8B2D-5A78BB6DCEB2}" type="datetimeFigureOut">
              <a:rPr lang="en-GB" smtClean="0"/>
              <a:t>28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E881FF-A2B6-DC26-446E-55CFBC8B08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CA45432-78BF-69E1-EB98-C6F2F3BB0E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B18D00-7A28-4BDF-9291-FC7511BAA2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241382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0EDA0C-D032-E63D-166D-2641A7366F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8FADC00-A275-4573-5589-5644AC7B231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B82E7B1-EBE3-5F0F-2E03-93D3C701B53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4992A77-EE82-5802-137D-CD1E76C171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CFFA6-FDB5-49AF-8B2D-5A78BB6DCEB2}" type="datetimeFigureOut">
              <a:rPr lang="en-GB" smtClean="0"/>
              <a:t>28/09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4532CD7-25D2-89CB-B3B5-2C3E779373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792A703-E4D6-87F8-FFB7-D70F5EDF09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B18D00-7A28-4BDF-9291-FC7511BAA2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167078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80482A-7F3F-BD24-2D88-11677526FB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07FDDA7-2D3A-39D2-D7C7-7A2A96B616F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6305199-21E8-C1D5-B4A3-C6DB730CC6F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05DA911-B2D7-DC83-CC0B-45AC0BAA74F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DACD792-3B70-FABC-51D7-EED00D89A64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AB4E4B5-E865-AD5F-AF6D-A0C0A1A12E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CFFA6-FDB5-49AF-8B2D-5A78BB6DCEB2}" type="datetimeFigureOut">
              <a:rPr lang="en-GB" smtClean="0"/>
              <a:t>28/09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59673F2-5477-23AD-FC39-91D6C3474B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19F1CFA-E889-2294-987F-E661F30DF9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B18D00-7A28-4BDF-9291-FC7511BAA2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090239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9AC2DF-C4BE-F718-0CD8-6E3493A764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78847DA-C843-B9C3-A441-6A30CC2395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CFFA6-FDB5-49AF-8B2D-5A78BB6DCEB2}" type="datetimeFigureOut">
              <a:rPr lang="en-GB" smtClean="0"/>
              <a:t>28/09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0E56C84-D76F-5899-ED61-4AF6B534FA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694B1E3-D6A3-664A-46B8-C8A060E8E4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B18D00-7A28-4BDF-9291-FC7511BAA2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111245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AB9B3A5-B57D-1853-F44E-E03113B8C0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CFFA6-FDB5-49AF-8B2D-5A78BB6DCEB2}" type="datetimeFigureOut">
              <a:rPr lang="en-GB" smtClean="0"/>
              <a:t>28/09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16EBBB2-0158-5447-0951-22548D15F5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D7DB68D-D27A-5AD2-0876-56A60144F8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B18D00-7A28-4BDF-9291-FC7511BAA2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737713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B3B2EB-C8B9-E0B5-4314-7E896E8D10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F7D7ADC-6286-E92B-7985-6545D0817F2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2F52C5B-69EA-E7E6-102F-308F07682DD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6541D4E-C51E-1ABE-8E96-32ECDEE091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CFFA6-FDB5-49AF-8B2D-5A78BB6DCEB2}" type="datetimeFigureOut">
              <a:rPr lang="en-GB" smtClean="0"/>
              <a:t>28/09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DBBBCD6-FC88-054B-37C7-C61AF84DA1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FA19F2F-F1B4-AB0D-79C5-C404219E2D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B18D00-7A28-4BDF-9291-FC7511BAA2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699282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307E2A-6A3C-5D07-2864-68C68FF901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CB83B18-7DF4-E4DB-B929-C0B8DF0C6FD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DEA0BCA-10D7-4957-2E33-972CCCB642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7A98CCB-F32F-42AA-C054-8564FADCC9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CFFA6-FDB5-49AF-8B2D-5A78BB6DCEB2}" type="datetimeFigureOut">
              <a:rPr lang="en-GB" smtClean="0"/>
              <a:t>28/09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C8A7FED-6B54-D096-80CE-5870C50A5B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C9B2222-E97A-BCEC-30D4-2853228D07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B18D00-7A28-4BDF-9291-FC7511BAA2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872221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906C3FD-1E75-C38A-F02E-7EFDC17AA1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1CF2682-AC00-0553-2F90-EF5A0D8428F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68F2821-C2FB-EAAB-8877-90F3A8E8F72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5CFFA6-FDB5-49AF-8B2D-5A78BB6DCEB2}" type="datetimeFigureOut">
              <a:rPr lang="en-GB" smtClean="0"/>
              <a:t>28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6246A8-F1D7-5A85-3FF7-F5366970725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51154A-AD64-1FB5-3012-D5C2C9BE7F6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B18D00-7A28-4BDF-9291-FC7511BAA2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64700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19721BBB-E5E7-47D8-7AFA-006B61B00FB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840141"/>
            <a:ext cx="12192000" cy="383123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686D54F-AF1D-42AD-383D-163BB62A221D}"/>
              </a:ext>
            </a:extLst>
          </p:cNvPr>
          <p:cNvSpPr txBox="1"/>
          <p:nvPr/>
        </p:nvSpPr>
        <p:spPr>
          <a:xfrm>
            <a:off x="1326382" y="5114611"/>
            <a:ext cx="945549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kern="10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le S6. </a:t>
            </a:r>
            <a:r>
              <a:rPr lang="en-GB" sz="1800" b="1" kern="1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) </a:t>
            </a:r>
            <a:r>
              <a:rPr lang="en-GB" sz="1800" kern="1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lasmid pErwimp001 annotation. </a:t>
            </a:r>
            <a:r>
              <a:rPr lang="en-GB" sz="1800" b="1" kern="1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) </a:t>
            </a:r>
            <a:r>
              <a:rPr lang="en-GB" sz="1800" kern="1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ocation of intimin/</a:t>
            </a:r>
            <a:r>
              <a:rPr lang="en-GB" sz="1800" kern="100" dirty="0" err="1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vasin</a:t>
            </a:r>
            <a:r>
              <a:rPr lang="en-GB" sz="1800" kern="1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like proteins on </a:t>
            </a:r>
            <a:r>
              <a:rPr lang="en-GB" sz="1800" kern="100" dirty="0" err="1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rwimp</a:t>
            </a:r>
            <a:r>
              <a:rPr lang="en-GB" sz="1800" kern="1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hromosome.</a:t>
            </a:r>
            <a:endParaRPr lang="en-GB" sz="18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2371463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2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ck Pilgrim</dc:creator>
  <cp:lastModifiedBy>Jack Pilgrim</cp:lastModifiedBy>
  <cp:revision>1</cp:revision>
  <dcterms:created xsi:type="dcterms:W3CDTF">2023-09-28T14:48:12Z</dcterms:created>
  <dcterms:modified xsi:type="dcterms:W3CDTF">2023-09-28T14:50:13Z</dcterms:modified>
</cp:coreProperties>
</file>